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  <p:sldId id="258" r:id="rId4"/>
    <p:sldId id="261" r:id="rId5"/>
    <p:sldId id="259" r:id="rId6"/>
    <p:sldId id="260" r:id="rId7"/>
    <p:sldId id="262" r:id="rId8"/>
    <p:sldId id="264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0" d="100"/>
          <a:sy n="60" d="100"/>
        </p:scale>
        <p:origin x="800" y="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4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4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4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4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4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4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4/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4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4/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4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4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5/4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11.png"/><Relationship Id="rId3" Type="http://schemas.microsoft.com/office/2007/relationships/hdphoto" Target="../media/hdphoto1.wdp"/><Relationship Id="rId7" Type="http://schemas.openxmlformats.org/officeDocument/2006/relationships/image" Target="../media/image8.png"/><Relationship Id="rId12" Type="http://schemas.microsoft.com/office/2007/relationships/hdphoto" Target="../media/hdphoto5.wdp"/><Relationship Id="rId2" Type="http://schemas.openxmlformats.org/officeDocument/2006/relationships/image" Target="../media/image5.png"/><Relationship Id="rId16" Type="http://schemas.microsoft.com/office/2007/relationships/hdphoto" Target="../media/hdphoto7.wdp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10.png"/><Relationship Id="rId5" Type="http://schemas.openxmlformats.org/officeDocument/2006/relationships/image" Target="../media/image7.png"/><Relationship Id="rId15" Type="http://schemas.openxmlformats.org/officeDocument/2006/relationships/image" Target="../media/image12.png"/><Relationship Id="rId10" Type="http://schemas.microsoft.com/office/2007/relationships/hdphoto" Target="../media/hdphoto4.wdp"/><Relationship Id="rId4" Type="http://schemas.openxmlformats.org/officeDocument/2006/relationships/image" Target="../media/image6.tiff"/><Relationship Id="rId9" Type="http://schemas.openxmlformats.org/officeDocument/2006/relationships/image" Target="../media/image9.png"/><Relationship Id="rId14" Type="http://schemas.microsoft.com/office/2007/relationships/hdphoto" Target="../media/hdphoto6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microsoft.com/office/2007/relationships/hdphoto" Target="../media/hdphoto8.wdp"/><Relationship Id="rId7" Type="http://schemas.microsoft.com/office/2007/relationships/hdphoto" Target="../media/hdphoto10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microsoft.com/office/2007/relationships/hdphoto" Target="../media/hdphoto9.wdp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microsoft.com/office/2007/relationships/hdphoto" Target="../media/hdphoto11.wdp"/><Relationship Id="rId7" Type="http://schemas.microsoft.com/office/2007/relationships/hdphoto" Target="../media/hdphoto13.wdp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microsoft.com/office/2007/relationships/hdphoto" Target="../media/hdphoto12.wdp"/><Relationship Id="rId4" Type="http://schemas.openxmlformats.org/officeDocument/2006/relationships/image" Target="../media/image1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microsoft.com/office/2007/relationships/hdphoto" Target="../media/hdphoto14.wdp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png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00247" y="308935"/>
            <a:ext cx="15191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H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025014" y="1446771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4914" y="1839538"/>
            <a:ext cx="3130286" cy="1589462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399206" y="1424774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NK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628896" y="2006600"/>
            <a:ext cx="2012703" cy="50057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BB4433B7-740F-AB5D-F0DE-E2DE30F508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25014" y="1839538"/>
            <a:ext cx="2600325" cy="1514475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25647" y="194635"/>
            <a:ext cx="14855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B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4225075" y="1277747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414454" y="1304486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NK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50475" y="1805625"/>
            <a:ext cx="3259249" cy="2033549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1547" y="1805625"/>
            <a:ext cx="3419253" cy="2033549"/>
          </a:xfrm>
          <a:prstGeom prst="rect">
            <a:avLst/>
          </a:prstGeom>
        </p:spPr>
      </p:pic>
      <p:sp>
        <p:nvSpPr>
          <p:cNvPr id="8" name="矩形 7"/>
          <p:cNvSpPr/>
          <p:nvPr/>
        </p:nvSpPr>
        <p:spPr>
          <a:xfrm>
            <a:off x="901700" y="2108200"/>
            <a:ext cx="2120900" cy="4953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-15653" y="93035"/>
            <a:ext cx="12803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图片 10" descr="图片包含 水, 鸟, 游戏机, 电脑&#10;&#10;描述已自动生成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838" y="1210072"/>
            <a:ext cx="2102695" cy="1300120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648584" y="829341"/>
            <a:ext cx="9925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CREB</a:t>
            </a: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944047" y="834004"/>
            <a:ext cx="7873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EB</a:t>
            </a: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3" name="图片 22" descr="水中的倒影&#10;&#10;低可信度描述已自动生成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491" y="3269635"/>
            <a:ext cx="2045054" cy="1042176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>
            <a:off x="6571153" y="2845560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4290838" y="2909104"/>
            <a:ext cx="7873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EB</a:t>
            </a: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8" name="图片 37"/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-20000"/>
                    </a14:imgEffect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763047" y="3240669"/>
            <a:ext cx="1188751" cy="1101442"/>
          </a:xfrm>
          <a:prstGeom prst="rect">
            <a:avLst/>
          </a:prstGeom>
        </p:spPr>
      </p:pic>
      <p:sp>
        <p:nvSpPr>
          <p:cNvPr id="39" name="文本框 38"/>
          <p:cNvSpPr txBox="1"/>
          <p:nvPr/>
        </p:nvSpPr>
        <p:spPr>
          <a:xfrm>
            <a:off x="2702103" y="2888139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CRE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648584" y="5164786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NK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3212930" y="5147656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79343" y="5744010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L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-19813" y="3445037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H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007481" y="1210072"/>
            <a:ext cx="2246358" cy="1337942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405818">
            <a:off x="648990" y="5513897"/>
            <a:ext cx="2374885" cy="1325632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179366" y="5501416"/>
            <a:ext cx="2367380" cy="1203290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63056" y="3240669"/>
            <a:ext cx="1713131" cy="1071142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616234" y="3233108"/>
            <a:ext cx="3100260" cy="1067639"/>
          </a:xfrm>
          <a:prstGeom prst="rect">
            <a:avLst/>
          </a:prstGeom>
        </p:spPr>
      </p:pic>
      <p:sp>
        <p:nvSpPr>
          <p:cNvPr id="33" name="矩形 32"/>
          <p:cNvSpPr/>
          <p:nvPr/>
        </p:nvSpPr>
        <p:spPr>
          <a:xfrm>
            <a:off x="6902685" y="3575034"/>
            <a:ext cx="1199915" cy="3685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rgbClr val="FF0000"/>
                </a:solidFill>
              </a:ln>
              <a:noFill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矩形 33"/>
          <p:cNvSpPr/>
          <p:nvPr/>
        </p:nvSpPr>
        <p:spPr>
          <a:xfrm>
            <a:off x="672753" y="3575034"/>
            <a:ext cx="869800" cy="3685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rgbClr val="FF0000"/>
                </a:solidFill>
              </a:ln>
              <a:noFill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438274" y="2911945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NK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矩形 39"/>
          <p:cNvSpPr/>
          <p:nvPr/>
        </p:nvSpPr>
        <p:spPr>
          <a:xfrm>
            <a:off x="705885" y="1843070"/>
            <a:ext cx="1385307" cy="3221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rgbClr val="FF0000"/>
                </a:solidFill>
              </a:ln>
              <a:noFill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25400" y="1565647"/>
            <a:ext cx="61341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C</a:t>
            </a:r>
            <a:endParaRPr lang="zh-CN" altLang="en-US" b="1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5147" y="156535"/>
            <a:ext cx="13765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T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97760" y="3812048"/>
            <a:ext cx="3976576" cy="1335685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311296" y="1226009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NK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24928" y="3493565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EB</a:t>
            </a:r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497968" y="3812048"/>
            <a:ext cx="1954176" cy="1287980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4468274" y="3465424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4125427" y="1305148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CRE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967719" y="4133715"/>
            <a:ext cx="1532276" cy="47354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125427" y="1671541"/>
            <a:ext cx="1762026" cy="1348279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29917" y="1598280"/>
            <a:ext cx="3680798" cy="1415203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647700" y="1749265"/>
            <a:ext cx="1376532" cy="4616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47847" y="54935"/>
            <a:ext cx="13893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D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4" name="图片 23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65331" y="1546458"/>
            <a:ext cx="3710729" cy="1190783"/>
          </a:xfrm>
          <a:prstGeom prst="rect">
            <a:avLst/>
          </a:prstGeom>
        </p:spPr>
      </p:pic>
      <p:sp>
        <p:nvSpPr>
          <p:cNvPr id="29" name="文本框 28"/>
          <p:cNvSpPr txBox="1"/>
          <p:nvPr/>
        </p:nvSpPr>
        <p:spPr>
          <a:xfrm>
            <a:off x="3404092" y="2896914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328544" y="1204294"/>
            <a:ext cx="10951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NK1</a:t>
            </a: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426778" y="2940493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CRE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2856023" y="1173567"/>
            <a:ext cx="7873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EB</a:t>
            </a: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4639924" y="1935479"/>
            <a:ext cx="1936136" cy="3585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07516" y="3306603"/>
            <a:ext cx="2289432" cy="1277098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343024" y="3306603"/>
            <a:ext cx="2824005" cy="1277098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7249" y="1604354"/>
            <a:ext cx="2453119" cy="1052347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1382912" y="1754813"/>
            <a:ext cx="1139308" cy="2847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73247" y="143835"/>
            <a:ext cx="12803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 descr="模糊的图片&#10;&#10;描述已自动生成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2184" y="1405521"/>
            <a:ext cx="3600494" cy="1566279"/>
          </a:xfrm>
          <a:prstGeom prst="rect">
            <a:avLst/>
          </a:prstGeom>
        </p:spPr>
      </p:pic>
      <p:pic>
        <p:nvPicPr>
          <p:cNvPr id="8" name="图片 7" descr="街道边的空地上&#10;&#10;中度可信度描述已自动生成"/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4855" y="3658870"/>
            <a:ext cx="2990850" cy="1386840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908314" y="1022351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NK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4402924" y="3211031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907425" y="3258735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NK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4404753" y="985873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27735" y="1430020"/>
            <a:ext cx="2808605" cy="165608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62462" y="3627769"/>
            <a:ext cx="3571641" cy="1386874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381000" y="20066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C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55600" y="42291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N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/>
          <p:cNvSpPr txBox="1"/>
          <p:nvPr/>
        </p:nvSpPr>
        <p:spPr>
          <a:xfrm>
            <a:off x="276447" y="435935"/>
            <a:ext cx="15544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Figure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0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89039" y="1587190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NK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824876" y="1594373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55299" y="1963704"/>
            <a:ext cx="3507113" cy="1716041"/>
          </a:xfrm>
          <a:prstGeom prst="rect">
            <a:avLst/>
          </a:prstGeom>
        </p:spPr>
      </p:pic>
      <p:sp>
        <p:nvSpPr>
          <p:cNvPr id="2" name="矩形 1"/>
          <p:cNvSpPr/>
          <p:nvPr/>
        </p:nvSpPr>
        <p:spPr>
          <a:xfrm>
            <a:off x="4215605" y="2333037"/>
            <a:ext cx="2497615" cy="69019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9086" y="1963704"/>
            <a:ext cx="2926444" cy="1716041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62147" y="359735"/>
            <a:ext cx="14455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Figure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1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3285" y="4310196"/>
            <a:ext cx="3235491" cy="2111869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87426" y="4296791"/>
            <a:ext cx="3235492" cy="2125274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631914" y="3975728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NK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4301427" y="3944335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19288" y="1611612"/>
            <a:ext cx="2490493" cy="1817387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9530916" y="1239205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79558" y="1653841"/>
            <a:ext cx="3295650" cy="1743075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3122249" y="1304701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CRE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6053347" y="1308418"/>
            <a:ext cx="7873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EB</a:t>
            </a: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图片 1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93423" y="1658515"/>
            <a:ext cx="2668244" cy="1738401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8039" y="1734680"/>
            <a:ext cx="2496439" cy="1647976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683285" y="1360396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NK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矩形 22"/>
          <p:cNvSpPr/>
          <p:nvPr/>
        </p:nvSpPr>
        <p:spPr>
          <a:xfrm>
            <a:off x="1026586" y="2293620"/>
            <a:ext cx="1790206" cy="3153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矩形 23"/>
          <p:cNvSpPr/>
          <p:nvPr/>
        </p:nvSpPr>
        <p:spPr>
          <a:xfrm>
            <a:off x="1382186" y="5290820"/>
            <a:ext cx="2199214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3</Words>
  <Application>Microsoft Office PowerPoint</Application>
  <PresentationFormat>宽屏</PresentationFormat>
  <Paragraphs>45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2" baseType="lpstr">
      <vt:lpstr>Arial</vt:lpstr>
      <vt:lpstr>Calibri</vt:lpstr>
      <vt:lpstr>Times New Roman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istrator</dc:creator>
  <cp:lastModifiedBy>e43554</cp:lastModifiedBy>
  <cp:revision>99</cp:revision>
  <dcterms:created xsi:type="dcterms:W3CDTF">2023-08-09T12:44:00Z</dcterms:created>
  <dcterms:modified xsi:type="dcterms:W3CDTF">2025-04-26T03:55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60B918677D1A4B96B4C15FDC3C80D138_13</vt:lpwstr>
  </property>
  <property fmtid="{D5CDD505-2E9C-101B-9397-08002B2CF9AE}" pid="3" name="KSOProductBuildVer">
    <vt:lpwstr>2052-12.1.0.20305</vt:lpwstr>
  </property>
</Properties>
</file>